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94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657" userDrawn="1">
          <p15:clr>
            <a:srgbClr val="A4A3A4"/>
          </p15:clr>
        </p15:guide>
        <p15:guide id="2" pos="5164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91D83F"/>
    <a:srgbClr val="9CEA45"/>
    <a:srgbClr val="5B994B"/>
    <a:srgbClr val="A2CE37"/>
    <a:srgbClr val="7CB84B"/>
    <a:srgbClr val="A4559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425" autoAdjust="0"/>
    <p:restoredTop sz="50000" autoAdjust="0"/>
  </p:normalViewPr>
  <p:slideViewPr>
    <p:cSldViewPr snapToGrid="0" snapToObjects="1" showGuides="1">
      <p:cViewPr>
        <p:scale>
          <a:sx n="130" d="100"/>
          <a:sy n="130" d="100"/>
        </p:scale>
        <p:origin x="1048" y="-216"/>
      </p:cViewPr>
      <p:guideLst>
        <p:guide orient="horz" pos="3657"/>
        <p:guide pos="5164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74264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0438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35591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525308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08301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40984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06895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42062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49889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26740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58139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DB8703-8810-574E-9B67-AA671BE73BC8}" type="datetimeFigureOut">
              <a:rPr lang="en-US" smtClean="0"/>
              <a:t>6/21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24D676-8607-E745-B5A7-930C53B1CB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09226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928448" y="5183173"/>
            <a:ext cx="726940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 smtClean="0"/>
              <a:t>Table S4. Summary of </a:t>
            </a:r>
            <a:r>
              <a:rPr lang="en-US" sz="1200" b="1" dirty="0" err="1" smtClean="0"/>
              <a:t>CytoSNP</a:t>
            </a:r>
            <a:r>
              <a:rPr lang="en-US" sz="1200" b="1" dirty="0" smtClean="0"/>
              <a:t> calls.</a:t>
            </a:r>
            <a:endParaRPr lang="en-US" sz="1200" dirty="0"/>
          </a:p>
        </p:txBody>
      </p:sp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27008033"/>
              </p:ext>
            </p:extLst>
          </p:nvPr>
        </p:nvGraphicFramePr>
        <p:xfrm>
          <a:off x="1160208" y="1397000"/>
          <a:ext cx="2422422" cy="370840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04566"/>
                <a:gridCol w="710382"/>
                <a:gridCol w="807474"/>
              </a:tblGrid>
              <a:tr h="37084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Sample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losses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gains</a:t>
                      </a:r>
                      <a:endParaRPr lang="en-US" sz="12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C1 CER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157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3</a:t>
                      </a:r>
                      <a:endParaRPr lang="en-US" sz="12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C2 CER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444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3</a:t>
                      </a:r>
                      <a:endParaRPr lang="en-US" sz="12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C3</a:t>
                      </a:r>
                      <a:r>
                        <a:rPr lang="en-US" sz="1200" baseline="0" dirty="0" smtClean="0"/>
                        <a:t> C</a:t>
                      </a:r>
                      <a:r>
                        <a:rPr lang="en-US" sz="1200" dirty="0" smtClean="0"/>
                        <a:t>ER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5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4</a:t>
                      </a:r>
                      <a:endParaRPr lang="en-US" sz="12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C4 CER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63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2</a:t>
                      </a:r>
                      <a:endParaRPr lang="en-US" sz="12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C2</a:t>
                      </a:r>
                      <a:r>
                        <a:rPr lang="en-US" sz="1200" baseline="0" dirty="0" smtClean="0"/>
                        <a:t> FCs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3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2</a:t>
                      </a:r>
                      <a:endParaRPr lang="en-US" sz="12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C3 FC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2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5</a:t>
                      </a:r>
                      <a:endParaRPr lang="en-US" sz="1200" dirty="0"/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C4 FC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85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2</a:t>
                      </a: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mean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115.1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3</a:t>
                      </a:r>
                    </a:p>
                  </a:txBody>
                  <a:tcPr/>
                </a:tc>
              </a:tr>
              <a:tr h="370840"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SD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153.6</a:t>
                      </a:r>
                      <a:endParaRPr lang="en-US" sz="1200" dirty="0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sz="1200" dirty="0" smtClean="0"/>
                        <a:t>1.2</a:t>
                      </a:r>
                    </a:p>
                  </a:txBody>
                  <a:tcPr/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9157260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466</TotalTime>
  <Words>45</Words>
  <Application>Microsoft Macintosh PowerPoint</Application>
  <PresentationFormat>On-screen Show (4:3)</PresentationFormat>
  <Paragraphs>3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Calibri</vt:lpstr>
      <vt:lpstr>Arial</vt:lpstr>
      <vt:lpstr>Office Theme</vt:lpstr>
      <vt:lpstr>PowerPoint Presentation</vt:lpstr>
    </vt:vector>
  </TitlesOfParts>
  <Company>UCLMS</Company>
  <LinksUpToDate>false</LinksUpToDate>
  <SharedDoc>false</SharedDoc>
  <HyperlinksChanged>false</HyperlinksChanged>
  <AppVersion>15.003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os Proukakis</dc:creator>
  <cp:lastModifiedBy>Christos Proukakis</cp:lastModifiedBy>
  <cp:revision>566</cp:revision>
  <dcterms:created xsi:type="dcterms:W3CDTF">2015-06-01T09:06:36Z</dcterms:created>
  <dcterms:modified xsi:type="dcterms:W3CDTF">2017-06-21T19:51:53Z</dcterms:modified>
</cp:coreProperties>
</file>